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1936">
          <p15:clr>
            <a:srgbClr val="A4A3A4"/>
          </p15:clr>
        </p15:guide>
        <p15:guide id="3" pos="3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rtier, Stephanie" initials="FS" lastIdx="4" clrIdx="0">
    <p:extLst/>
  </p:cmAuthor>
  <p:cmAuthor id="2" name="Andrew Stiff" initials="" lastIdx="0" clrIdx="1"/>
  <p:cmAuthor id="3" name="Sobrina Wesolowski" initials="SW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03" autoAdjust="0"/>
    <p:restoredTop sz="93918" autoAdjust="0"/>
  </p:normalViewPr>
  <p:slideViewPr>
    <p:cSldViewPr snapToGrid="0">
      <p:cViewPr varScale="1">
        <p:scale>
          <a:sx n="48" d="100"/>
          <a:sy n="48" d="100"/>
        </p:scale>
        <p:origin x="-3108" y="-120"/>
      </p:cViewPr>
      <p:guideLst>
        <p:guide orient="horz" pos="3840"/>
        <p:guide pos="1936"/>
        <p:guide pos="3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BB1863-6C78-4199-A00B-2F07DD958D56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426DA3-EA64-413C-AC60-7E90D2A03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21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0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5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7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2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786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50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66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5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74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45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443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3813860"/>
              </p:ext>
            </p:extLst>
          </p:nvPr>
        </p:nvGraphicFramePr>
        <p:xfrm>
          <a:off x="244549" y="1132666"/>
          <a:ext cx="6507126" cy="729041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99240">
                  <a:extLst>
                    <a:ext uri="{9D8B030D-6E8A-4147-A177-3AD203B41FA5}">
                      <a16:colId xmlns:a16="http://schemas.microsoft.com/office/drawing/2014/main" xmlns="" val="538729835"/>
                    </a:ext>
                  </a:extLst>
                </a:gridCol>
                <a:gridCol w="170749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9915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77311">
                  <a:extLst>
                    <a:ext uri="{9D8B030D-6E8A-4147-A177-3AD203B41FA5}">
                      <a16:colId xmlns:a16="http://schemas.microsoft.com/office/drawing/2014/main" xmlns="" val="2680922805"/>
                    </a:ext>
                  </a:extLst>
                </a:gridCol>
                <a:gridCol w="71316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70785">
                  <a:extLst>
                    <a:ext uri="{9D8B030D-6E8A-4147-A177-3AD203B41FA5}">
                      <a16:colId xmlns:a16="http://schemas.microsoft.com/office/drawing/2014/main" xmlns="" val="1295131219"/>
                    </a:ext>
                  </a:extLst>
                </a:gridCol>
                <a:gridCol w="839973">
                  <a:extLst>
                    <a:ext uri="{9D8B030D-6E8A-4147-A177-3AD203B41FA5}">
                      <a16:colId xmlns:a16="http://schemas.microsoft.com/office/drawing/2014/main" xmlns="" val="1108653980"/>
                    </a:ext>
                  </a:extLst>
                </a:gridCol>
              </a:tblGrid>
              <a:tr h="345260">
                <a:tc rowSpan="2" gridSpan="2"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positive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negative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57714">
                <a:tc gridSpan="2" vMerge="1"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b="1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4242567296"/>
                  </a:ext>
                </a:extLst>
              </a:tr>
              <a:tr h="332118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NAC</a:t>
                      </a:r>
                      <a:endParaRPr lang="en-US" sz="14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+ T cells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2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5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6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98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2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3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76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953843220"/>
                  </a:ext>
                </a:extLst>
              </a:tr>
              <a:tr h="33211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40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56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62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932488495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1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8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4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70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344560836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0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7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1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36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682801712"/>
                  </a:ext>
                </a:extLst>
              </a:tr>
              <a:tr h="331234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NAC</a:t>
                      </a:r>
                      <a:endParaRPr lang="en-US" sz="14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+ T cells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3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8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96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156766006"/>
                  </a:ext>
                </a:extLst>
              </a:tr>
              <a:tr h="324765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7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2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84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4020587007"/>
                  </a:ext>
                </a:extLst>
              </a:tr>
              <a:tr h="33123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40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7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26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257079666"/>
                  </a:ext>
                </a:extLst>
              </a:tr>
              <a:tr h="33123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1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5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34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135161066"/>
                  </a:ext>
                </a:extLst>
              </a:tr>
              <a:tr h="331234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2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6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95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318631953"/>
                  </a:ext>
                </a:extLst>
              </a:tr>
              <a:tr h="263649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NAC</a:t>
                      </a:r>
                      <a:endParaRPr lang="en-US" sz="14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 T cells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3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7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8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88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535162925"/>
                  </a:ext>
                </a:extLst>
              </a:tr>
              <a:tr h="33476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5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6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18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581980012"/>
                  </a:ext>
                </a:extLst>
              </a:tr>
              <a:tr h="334770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40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9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6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78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557972939"/>
                  </a:ext>
                </a:extLst>
              </a:tr>
              <a:tr h="33476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1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1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4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77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72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1919492204"/>
                  </a:ext>
                </a:extLst>
              </a:tr>
              <a:tr h="33476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9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53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5</a:t>
                      </a:r>
                    </a:p>
                  </a:txBody>
                  <a:tcPr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3951859"/>
                  </a:ext>
                </a:extLst>
              </a:tr>
              <a:tr h="332118">
                <a:tc rowSpan="5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NAC</a:t>
                      </a:r>
                      <a:endParaRPr lang="en-US" sz="14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+ T cells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4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4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7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8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18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3983687065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g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7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1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2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70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352678447"/>
                  </a:ext>
                </a:extLst>
              </a:tr>
              <a:tr h="282491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X40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8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0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6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7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21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011297306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1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9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4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28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77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38548013"/>
                  </a:ext>
                </a:extLst>
              </a:tr>
              <a:tr h="33211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3+</a:t>
                      </a:r>
                      <a:endParaRPr lang="en-US" sz="14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6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11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4</a:t>
                      </a: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04</a:t>
                      </a: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xmlns="" val="2258059024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62996" y="512172"/>
            <a:ext cx="564669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4. ICP expression differences between HR positive and HR negative breast cancer patients</a:t>
            </a:r>
          </a:p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0673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28</TotalTime>
  <Words>185</Words>
  <Application>Microsoft Office PowerPoint</Application>
  <PresentationFormat>Custom</PresentationFormat>
  <Paragraphs>1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ff, Andrew</dc:creator>
  <cp:lastModifiedBy>MPABLEO</cp:lastModifiedBy>
  <cp:revision>188</cp:revision>
  <dcterms:created xsi:type="dcterms:W3CDTF">2018-09-28T15:43:32Z</dcterms:created>
  <dcterms:modified xsi:type="dcterms:W3CDTF">2020-05-13T11:10:42Z</dcterms:modified>
</cp:coreProperties>
</file>